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46" r:id="rId2"/>
    <p:sldId id="325" r:id="rId3"/>
    <p:sldId id="342" r:id="rId4"/>
    <p:sldId id="341" r:id="rId5"/>
    <p:sldId id="25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lina Lliberos Requesens" initials="CLR" lastIdx="4" clrIdx="0">
    <p:extLst>
      <p:ext uri="{19B8F6BF-5375-455C-9EA6-DF929625EA0E}">
        <p15:presenceInfo xmlns:p15="http://schemas.microsoft.com/office/powerpoint/2012/main" userId="S::Carolina.LliberosRequesens@monash.edu::8565dbd4-c0ab-4fb1-92f2-b2d093ffb93c" providerId="AD"/>
      </p:ext>
    </p:extLst>
  </p:cmAuthor>
  <p:cmAuthor id="2" name="Karla Hutt" initials="KH" lastIdx="3" clrIdx="1">
    <p:extLst>
      <p:ext uri="{19B8F6BF-5375-455C-9EA6-DF929625EA0E}">
        <p15:presenceInfo xmlns:p15="http://schemas.microsoft.com/office/powerpoint/2012/main" userId="S-1-5-21-948756243-734778046-674738317-1103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E6231"/>
    <a:srgbClr val="9DC3E6"/>
    <a:srgbClr val="FFC000"/>
    <a:srgbClr val="53EA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777" autoAdjust="0"/>
    <p:restoredTop sz="96357" autoAdjust="0"/>
  </p:normalViewPr>
  <p:slideViewPr>
    <p:cSldViewPr snapToGrid="0">
      <p:cViewPr varScale="1">
        <p:scale>
          <a:sx n="77" d="100"/>
          <a:sy n="77" d="100"/>
        </p:scale>
        <p:origin x="28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4F3443-BB9B-49D9-8049-838A20869185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8B297B-80D4-46BC-AD31-9AFEBD9A861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7640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50328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1801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729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197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6440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6436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576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9368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3682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3431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9657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1A3F4-4503-4F70-8EFB-EC106B93E0F9}" type="datetimeFigureOut">
              <a:rPr lang="en-AU" smtClean="0"/>
              <a:t>15/1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9068C-D56F-4128-9048-E206D0F6B3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9551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>
            <a:extLst>
              <a:ext uri="{FF2B5EF4-FFF2-40B4-BE49-F238E27FC236}">
                <a16:creationId xmlns:a16="http://schemas.microsoft.com/office/drawing/2014/main" id="{A6BBE4CB-B54D-492E-868E-27DBE829A0FB}"/>
              </a:ext>
            </a:extLst>
          </p:cNvPr>
          <p:cNvGrpSpPr/>
          <p:nvPr/>
        </p:nvGrpSpPr>
        <p:grpSpPr>
          <a:xfrm>
            <a:off x="520426" y="3398298"/>
            <a:ext cx="5817148" cy="3109404"/>
            <a:chOff x="431380" y="2426065"/>
            <a:chExt cx="5817148" cy="3109404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F737118-C4FB-4782-9DFD-C86FD5A1D52B}"/>
                </a:ext>
              </a:extLst>
            </p:cNvPr>
            <p:cNvSpPr txBox="1"/>
            <p:nvPr/>
          </p:nvSpPr>
          <p:spPr>
            <a:xfrm rot="16200000">
              <a:off x="266134" y="3338647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201DCEF-195E-458D-B3B0-36B6A29627F2}"/>
                </a:ext>
              </a:extLst>
            </p:cNvPr>
            <p:cNvSpPr txBox="1"/>
            <p:nvPr/>
          </p:nvSpPr>
          <p:spPr>
            <a:xfrm>
              <a:off x="621515" y="3709756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Picture 54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BA2C91D7-C954-4F21-B0F0-D922F53309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16" r="1" b="5882"/>
            <a:stretch/>
          </p:blipFill>
          <p:spPr>
            <a:xfrm>
              <a:off x="4939127" y="4004624"/>
              <a:ext cx="1299854" cy="1326509"/>
            </a:xfrm>
            <a:prstGeom prst="rect">
              <a:avLst/>
            </a:prstGeom>
          </p:spPr>
        </p:pic>
        <p:pic>
          <p:nvPicPr>
            <p:cNvPr id="57" name="Picture 56" descr="A picture containing game&#10;&#10;Description automatically generated">
              <a:extLst>
                <a:ext uri="{FF2B5EF4-FFF2-40B4-BE49-F238E27FC236}">
                  <a16:creationId xmlns:a16="http://schemas.microsoft.com/office/drawing/2014/main" id="{D2E617BA-7B6E-4D0D-A5AB-375F3FED41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32" b="5735"/>
            <a:stretch/>
          </p:blipFill>
          <p:spPr>
            <a:xfrm>
              <a:off x="3502432" y="4004622"/>
              <a:ext cx="1299042" cy="1326511"/>
            </a:xfrm>
            <a:prstGeom prst="rect">
              <a:avLst/>
            </a:prstGeom>
          </p:spPr>
        </p:pic>
        <p:pic>
          <p:nvPicPr>
            <p:cNvPr id="59" name="Picture 58" descr="A close up of a logo&#10;&#10;Description automatically generated">
              <a:extLst>
                <a:ext uri="{FF2B5EF4-FFF2-40B4-BE49-F238E27FC236}">
                  <a16:creationId xmlns:a16="http://schemas.microsoft.com/office/drawing/2014/main" id="{00F771FC-14C4-4317-96DE-EB6EBD8572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45" r="1" b="5735"/>
            <a:stretch/>
          </p:blipFill>
          <p:spPr>
            <a:xfrm>
              <a:off x="2076814" y="4002992"/>
              <a:ext cx="1299042" cy="1328141"/>
            </a:xfrm>
            <a:prstGeom prst="rect">
              <a:avLst/>
            </a:prstGeom>
          </p:spPr>
        </p:pic>
        <p:pic>
          <p:nvPicPr>
            <p:cNvPr id="61" name="Picture 60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B093913E-D04E-4518-B4BB-21D4A7DADE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57" b="5701"/>
            <a:stretch/>
          </p:blipFill>
          <p:spPr>
            <a:xfrm>
              <a:off x="637015" y="4001510"/>
              <a:ext cx="1307296" cy="1328141"/>
            </a:xfrm>
            <a:prstGeom prst="rect">
              <a:avLst/>
            </a:prstGeom>
          </p:spPr>
        </p:pic>
        <p:pic>
          <p:nvPicPr>
            <p:cNvPr id="63" name="Picture 62" descr="A picture containing monitor, sitting, table, rain&#10;&#10;Description automatically generated">
              <a:extLst>
                <a:ext uri="{FF2B5EF4-FFF2-40B4-BE49-F238E27FC236}">
                  <a16:creationId xmlns:a16="http://schemas.microsoft.com/office/drawing/2014/main" id="{504796CA-4486-439E-A6DB-4076130173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10" b="5735"/>
            <a:stretch/>
          </p:blipFill>
          <p:spPr>
            <a:xfrm>
              <a:off x="637015" y="2426065"/>
              <a:ext cx="1312767" cy="1328141"/>
            </a:xfrm>
            <a:prstGeom prst="rect">
              <a:avLst/>
            </a:prstGeom>
          </p:spPr>
        </p:pic>
        <p:pic>
          <p:nvPicPr>
            <p:cNvPr id="65" name="Picture 64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563E9C02-FDC9-4CEB-8DAB-A4CF74E499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12" b="5816"/>
            <a:stretch/>
          </p:blipFill>
          <p:spPr>
            <a:xfrm>
              <a:off x="2081896" y="2427660"/>
              <a:ext cx="1299043" cy="1326546"/>
            </a:xfrm>
            <a:prstGeom prst="rect">
              <a:avLst/>
            </a:prstGeom>
          </p:spPr>
        </p:pic>
        <p:pic>
          <p:nvPicPr>
            <p:cNvPr id="67" name="Picture 66" descr="A close up of a logo&#10;&#10;Description automatically generated">
              <a:extLst>
                <a:ext uri="{FF2B5EF4-FFF2-40B4-BE49-F238E27FC236}">
                  <a16:creationId xmlns:a16="http://schemas.microsoft.com/office/drawing/2014/main" id="{8CAFD8F0-CFD8-465F-AD39-AEE16630D2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06" b="5557"/>
            <a:stretch/>
          </p:blipFill>
          <p:spPr>
            <a:xfrm>
              <a:off x="3507970" y="2427547"/>
              <a:ext cx="1298552" cy="1328141"/>
            </a:xfrm>
            <a:prstGeom prst="rect">
              <a:avLst/>
            </a:prstGeom>
          </p:spPr>
        </p:pic>
        <p:pic>
          <p:nvPicPr>
            <p:cNvPr id="69" name="Picture 68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801C1D39-F28E-457C-AE01-59B7FF31F3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38" b="6063"/>
            <a:stretch/>
          </p:blipFill>
          <p:spPr>
            <a:xfrm>
              <a:off x="4943449" y="2426065"/>
              <a:ext cx="1305079" cy="1328141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C657118-EF84-4168-87E5-E1AC2BEC99F5}"/>
                </a:ext>
              </a:extLst>
            </p:cNvPr>
            <p:cNvSpPr txBox="1"/>
            <p:nvPr/>
          </p:nvSpPr>
          <p:spPr>
            <a:xfrm rot="16200000">
              <a:off x="265790" y="4915175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1A8F03C-8DAE-42B8-B383-BF1CAB2E1C57}"/>
                </a:ext>
              </a:extLst>
            </p:cNvPr>
            <p:cNvSpPr txBox="1"/>
            <p:nvPr/>
          </p:nvSpPr>
          <p:spPr>
            <a:xfrm>
              <a:off x="624315" y="5286284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B73936F-072A-490E-A94C-3B9392FA4692}"/>
                </a:ext>
              </a:extLst>
            </p:cNvPr>
            <p:cNvSpPr txBox="1"/>
            <p:nvPr/>
          </p:nvSpPr>
          <p:spPr>
            <a:xfrm rot="16200000">
              <a:off x="1732514" y="4911428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K1.1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E0F2E93-39D0-4523-A607-6356B6B88584}"/>
                </a:ext>
              </a:extLst>
            </p:cNvPr>
            <p:cNvSpPr txBox="1"/>
            <p:nvPr/>
          </p:nvSpPr>
          <p:spPr>
            <a:xfrm>
              <a:off x="2075810" y="5282537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1E57F93-67FE-4E3E-B82B-9EBA49DD875B}"/>
                </a:ext>
              </a:extLst>
            </p:cNvPr>
            <p:cNvSpPr txBox="1"/>
            <p:nvPr/>
          </p:nvSpPr>
          <p:spPr>
            <a:xfrm rot="16200000">
              <a:off x="3164059" y="4918139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K1.1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8FB1F56-3AA6-4F5B-8B3F-D100FF5F9B30}"/>
                </a:ext>
              </a:extLst>
            </p:cNvPr>
            <p:cNvSpPr txBox="1"/>
            <p:nvPr/>
          </p:nvSpPr>
          <p:spPr>
            <a:xfrm>
              <a:off x="3507355" y="5289248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0DB2CC1-1B9A-4CB3-BF4B-5AA1866DFBAC}"/>
                </a:ext>
              </a:extLst>
            </p:cNvPr>
            <p:cNvSpPr txBox="1"/>
            <p:nvPr/>
          </p:nvSpPr>
          <p:spPr>
            <a:xfrm rot="16200000">
              <a:off x="4652523" y="497492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7110423-35D1-4BD6-8ECE-B186D70DD208}"/>
                </a:ext>
              </a:extLst>
            </p:cNvPr>
            <p:cNvSpPr txBox="1"/>
            <p:nvPr/>
          </p:nvSpPr>
          <p:spPr>
            <a:xfrm>
              <a:off x="4942920" y="5282537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8a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2AA8C38-8254-4ABB-A7A5-77B103BA6097}"/>
                </a:ext>
              </a:extLst>
            </p:cNvPr>
            <p:cNvSpPr txBox="1"/>
            <p:nvPr/>
          </p:nvSpPr>
          <p:spPr>
            <a:xfrm rot="16200000">
              <a:off x="1596584" y="3261906"/>
              <a:ext cx="7954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ive-Dead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D730904E-480A-4D51-99EF-B2157DA79338}"/>
                </a:ext>
              </a:extLst>
            </p:cNvPr>
            <p:cNvCxnSpPr>
              <a:cxnSpLocks/>
            </p:cNvCxnSpPr>
            <p:nvPr/>
          </p:nvCxnSpPr>
          <p:spPr>
            <a:xfrm>
              <a:off x="1158603" y="3877816"/>
              <a:ext cx="21558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42B4430-1B9C-4272-853D-F7F67FEB8C70}"/>
                </a:ext>
              </a:extLst>
            </p:cNvPr>
            <p:cNvSpPr txBox="1"/>
            <p:nvPr/>
          </p:nvSpPr>
          <p:spPr>
            <a:xfrm rot="16200000">
              <a:off x="3124796" y="3338106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6B2E836-7A98-4E25-819D-AA04A81631C1}"/>
                </a:ext>
              </a:extLst>
            </p:cNvPr>
            <p:cNvSpPr txBox="1"/>
            <p:nvPr/>
          </p:nvSpPr>
          <p:spPr>
            <a:xfrm>
              <a:off x="3483382" y="3709215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25E552F-79C0-42E1-9C3E-C30AEFE7DEE7}"/>
                </a:ext>
              </a:extLst>
            </p:cNvPr>
            <p:cNvSpPr txBox="1"/>
            <p:nvPr/>
          </p:nvSpPr>
          <p:spPr>
            <a:xfrm rot="16200000">
              <a:off x="4577429" y="3342200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E73D438-8278-47DC-B0BB-7126A5C72C8B}"/>
                </a:ext>
              </a:extLst>
            </p:cNvPr>
            <p:cNvSpPr txBox="1"/>
            <p:nvPr/>
          </p:nvSpPr>
          <p:spPr>
            <a:xfrm>
              <a:off x="4936015" y="3713309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4/80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42615466-EB16-4073-A06D-AD5892FA968D}"/>
                </a:ext>
              </a:extLst>
            </p:cNvPr>
            <p:cNvCxnSpPr>
              <a:cxnSpLocks/>
            </p:cNvCxnSpPr>
            <p:nvPr/>
          </p:nvCxnSpPr>
          <p:spPr>
            <a:xfrm>
              <a:off x="4233709" y="2753827"/>
              <a:ext cx="761944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6BE490A9-C045-487D-A950-A0C77FFFA8EF}"/>
                </a:ext>
              </a:extLst>
            </p:cNvPr>
            <p:cNvCxnSpPr>
              <a:cxnSpLocks/>
            </p:cNvCxnSpPr>
            <p:nvPr/>
          </p:nvCxnSpPr>
          <p:spPr>
            <a:xfrm>
              <a:off x="4432573" y="3617453"/>
              <a:ext cx="536139" cy="464515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ADB511D1-B9F2-4851-9017-E599A29CAC6C}"/>
                </a:ext>
              </a:extLst>
            </p:cNvPr>
            <p:cNvCxnSpPr>
              <a:cxnSpLocks/>
            </p:cNvCxnSpPr>
            <p:nvPr/>
          </p:nvCxnSpPr>
          <p:spPr>
            <a:xfrm>
              <a:off x="2638734" y="4314638"/>
              <a:ext cx="921908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>
              <a:extLst>
                <a:ext uri="{FF2B5EF4-FFF2-40B4-BE49-F238E27FC236}">
                  <a16:creationId xmlns:a16="http://schemas.microsoft.com/office/drawing/2014/main" id="{26DC4935-094F-4875-AB53-0F2EEB7A9F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28848" y="3753665"/>
              <a:ext cx="0" cy="688559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596FF2B4-7740-4086-989F-AB6A646C37D9}"/>
                </a:ext>
              </a:extLst>
            </p:cNvPr>
            <p:cNvCxnSpPr>
              <a:cxnSpLocks/>
            </p:cNvCxnSpPr>
            <p:nvPr/>
          </p:nvCxnSpPr>
          <p:spPr>
            <a:xfrm>
              <a:off x="1819760" y="3461216"/>
              <a:ext cx="505092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A67B50A7-1468-4088-BEE7-6B5AF51F225E}"/>
                </a:ext>
              </a:extLst>
            </p:cNvPr>
            <p:cNvCxnSpPr>
              <a:cxnSpLocks/>
            </p:cNvCxnSpPr>
            <p:nvPr/>
          </p:nvCxnSpPr>
          <p:spPr>
            <a:xfrm>
              <a:off x="2772128" y="3533225"/>
              <a:ext cx="0" cy="466661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>
              <a:extLst>
                <a:ext uri="{FF2B5EF4-FFF2-40B4-BE49-F238E27FC236}">
                  <a16:creationId xmlns:a16="http://schemas.microsoft.com/office/drawing/2014/main" id="{B8D93E2D-C098-4DCC-A909-9EABB07D6854}"/>
                </a:ext>
              </a:extLst>
            </p:cNvPr>
            <p:cNvCxnSpPr>
              <a:cxnSpLocks/>
            </p:cNvCxnSpPr>
            <p:nvPr/>
          </p:nvCxnSpPr>
          <p:spPr>
            <a:xfrm>
              <a:off x="3220323" y="3339871"/>
              <a:ext cx="340319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8D0E7DF-0AF3-44E8-81CB-12DC6C8CDD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426" y="6951636"/>
            <a:ext cx="580760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ing strategy used to identify different immune cell populations in ovaries from 9-month-old WT and </a:t>
            </a:r>
            <a:r>
              <a:rPr kumimoji="0" lang="en-AU" altLang="en-US" sz="1200" b="0" i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</a:t>
            </a:r>
            <a:r>
              <a:rPr kumimoji="0" lang="en-AU" altLang="en-US" sz="1200" b="0" i="1" strike="noStrike" cap="none" normalizeH="0" baseline="3000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. n = 3-5 per cohort. </a:t>
            </a:r>
            <a:endParaRPr kumimoji="0" lang="en-AU" altLang="en-US" sz="18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0842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89976F3-B17A-4167-82B2-EAD2367156B4}"/>
              </a:ext>
            </a:extLst>
          </p:cNvPr>
          <p:cNvGrpSpPr/>
          <p:nvPr/>
        </p:nvGrpSpPr>
        <p:grpSpPr>
          <a:xfrm>
            <a:off x="798888" y="3841748"/>
            <a:ext cx="5527231" cy="2222503"/>
            <a:chOff x="818061" y="3721100"/>
            <a:chExt cx="5527231" cy="2222503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2B0985A5-E947-4095-BC04-CA94593726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685640"/>
                </p:ext>
              </p:extLst>
            </p:nvPr>
          </p:nvGraphicFramePr>
          <p:xfrm>
            <a:off x="3562505" y="3722652"/>
            <a:ext cx="2782787" cy="22209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907" name="Prism 8" r:id="rId3" imgW="4212507" imgH="3363920" progId="Prism8.Document">
                    <p:embed/>
                  </p:oleObj>
                </mc:Choice>
                <mc:Fallback>
                  <p:oleObj name="Prism 8" r:id="rId3" imgW="4212507" imgH="3363920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2B0985A5-E947-4095-BC04-CA94593726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562505" y="3722652"/>
                          <a:ext cx="2782787" cy="222095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BD8792F9-4E7E-4F99-B45F-D37FD01789F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5502862"/>
                </p:ext>
              </p:extLst>
            </p:nvPr>
          </p:nvGraphicFramePr>
          <p:xfrm>
            <a:off x="979488" y="3721100"/>
            <a:ext cx="2671762" cy="2222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908" name="Prism 8" r:id="rId5" imgW="4041803" imgH="3363920" progId="Prism8.Document">
                    <p:embed/>
                  </p:oleObj>
                </mc:Choice>
                <mc:Fallback>
                  <p:oleObj name="Prism 8" r:id="rId5" imgW="4041803" imgH="3363920" progId="Prism8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BD8792F9-4E7E-4F99-B45F-D37FD01789F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979488" y="3721100"/>
                          <a:ext cx="2671762" cy="2222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DF130A1-3E6F-4417-A78C-8374D4CA5EE7}"/>
                </a:ext>
              </a:extLst>
            </p:cNvPr>
            <p:cNvSpPr txBox="1"/>
            <p:nvPr/>
          </p:nvSpPr>
          <p:spPr>
            <a:xfrm>
              <a:off x="818061" y="3781218"/>
              <a:ext cx="281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0C6E1A2-8A5A-49BD-905F-D2BDFC9353F5}"/>
                </a:ext>
              </a:extLst>
            </p:cNvPr>
            <p:cNvSpPr txBox="1"/>
            <p:nvPr/>
          </p:nvSpPr>
          <p:spPr>
            <a:xfrm>
              <a:off x="3421920" y="3781218"/>
              <a:ext cx="281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Rectangle 588">
            <a:extLst>
              <a:ext uri="{FF2B5EF4-FFF2-40B4-BE49-F238E27FC236}">
                <a16:creationId xmlns:a16="http://schemas.microsoft.com/office/drawing/2014/main" id="{6DA56F63-D1A7-4A91-95F1-6DA1C5620A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8888" y="6441064"/>
            <a:ext cx="552723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Number of total oocytes (A) and MII stage oocytes (B) harvested from 12-month-old WT, </a:t>
            </a:r>
            <a:r>
              <a:rPr kumimoji="0" lang="en-AU" altLang="en-US" sz="1200" b="0" i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</a:t>
            </a:r>
            <a:r>
              <a:rPr kumimoji="0" lang="en-AU" altLang="en-US" sz="1200" b="0" i="1" strike="noStrike" cap="none" normalizeH="0" baseline="3000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kumimoji="0" lang="en-AU" altLang="en-US" sz="1200" b="0" i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kumimoji="0" lang="en-AU" altLang="en-US" sz="1200" b="0" i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lrp3</a:t>
            </a:r>
            <a:r>
              <a:rPr kumimoji="0" lang="en-AU" altLang="en-US" sz="1200" b="0" i="1" strike="noStrike" cap="none" normalizeH="0" baseline="3000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 n = 3-5 per cohort. Data are presented as </a:t>
            </a:r>
            <a:r>
              <a:rPr kumimoji="0" lang="en-AU" altLang="en-US" sz="1200" b="0" i="0" strike="noStrike" cap="none" normalizeH="0" baseline="0" dirty="0" err="1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Student’s t-test (A) or Mann-Whitney test (B) (</a:t>
            </a:r>
            <a:r>
              <a:rPr kumimoji="0" lang="en-AU" altLang="en-US" sz="1200" b="0" i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&gt;</a:t>
            </a:r>
            <a:r>
              <a:rPr kumimoji="0" lang="en-AU" altLang="en-US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0.05).</a:t>
            </a:r>
            <a:endParaRPr kumimoji="0" lang="en-AU" altLang="en-US" sz="18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6745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2CBAD4E-D04D-4CAE-A7F6-F47158D982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5824996"/>
              </p:ext>
            </p:extLst>
          </p:nvPr>
        </p:nvGraphicFramePr>
        <p:xfrm>
          <a:off x="1630680" y="3706799"/>
          <a:ext cx="3596640" cy="1956816"/>
        </p:xfrm>
        <a:graphic>
          <a:graphicData uri="http://schemas.openxmlformats.org/drawingml/2006/table">
            <a:tbl>
              <a:tblPr firstRow="1" firstCol="1" bandRow="1"/>
              <a:tblGrid>
                <a:gridCol w="1798320">
                  <a:extLst>
                    <a:ext uri="{9D8B030D-6E8A-4147-A177-3AD203B41FA5}">
                      <a16:colId xmlns:a16="http://schemas.microsoft.com/office/drawing/2014/main" val="4221863043"/>
                    </a:ext>
                  </a:extLst>
                </a:gridCol>
                <a:gridCol w="1798320">
                  <a:extLst>
                    <a:ext uri="{9D8B030D-6E8A-4147-A177-3AD203B41FA5}">
                      <a16:colId xmlns:a16="http://schemas.microsoft.com/office/drawing/2014/main" val="206733988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ce genotype</a:t>
                      </a:r>
                      <a:br>
                        <a:rPr lang="en-AU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AU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9-month-old)</a:t>
                      </a:r>
                      <a:endParaRPr lang="en-AU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ge of </a:t>
                      </a:r>
                      <a:r>
                        <a:rPr lang="en-AU" sz="11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trous</a:t>
                      </a:r>
                      <a:r>
                        <a:rPr lang="en-AU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ycle</a:t>
                      </a:r>
                      <a:endParaRPr lang="en-AU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71285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AU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trus</a:t>
                      </a:r>
                      <a:endParaRPr lang="en-AU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968177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73209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428008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781110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estrus</a:t>
                      </a:r>
                      <a:endParaRPr lang="en-AU" sz="11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096679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1241236"/>
                  </a:ext>
                </a:extLst>
              </a:tr>
              <a:tr h="0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AU" sz="1100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c</a:t>
                      </a:r>
                      <a:r>
                        <a:rPr lang="en-AU" sz="11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100" i="1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/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trus</a:t>
                      </a:r>
                      <a:endParaRPr lang="en-AU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498136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20662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AU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estru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5618937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4B5D3725-FD9A-4E42-938E-88405EA4FD2C}"/>
              </a:ext>
            </a:extLst>
          </p:cNvPr>
          <p:cNvSpPr/>
          <p:nvPr/>
        </p:nvSpPr>
        <p:spPr>
          <a:xfrm>
            <a:off x="548640" y="3083066"/>
            <a:ext cx="55595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1. </a:t>
            </a:r>
            <a:r>
              <a:rPr lang="en-AU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ge of mouse estrous cycle (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mice (n = 5) and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c</a:t>
            </a:r>
            <a:r>
              <a:rPr lang="en-AU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(n = 3)) </a:t>
            </a:r>
            <a:r>
              <a:rPr lang="en-AU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ediately after being sacrificed by isoflurane inhalation at 9 months of age. Each line indicates one mouse.</a:t>
            </a:r>
            <a:endParaRPr lang="en-AU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0494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194D8CD-06F1-458C-A66B-DEBD7F50AB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8774009"/>
              </p:ext>
            </p:extLst>
          </p:nvPr>
        </p:nvGraphicFramePr>
        <p:xfrm>
          <a:off x="640715" y="3253264"/>
          <a:ext cx="5576570" cy="4732020"/>
        </p:xfrm>
        <a:graphic>
          <a:graphicData uri="http://schemas.openxmlformats.org/drawingml/2006/table">
            <a:tbl>
              <a:tblPr firstRow="1" firstCol="1" bandRow="1"/>
              <a:tblGrid>
                <a:gridCol w="2070100">
                  <a:extLst>
                    <a:ext uri="{9D8B030D-6E8A-4147-A177-3AD203B41FA5}">
                      <a16:colId xmlns:a16="http://schemas.microsoft.com/office/drawing/2014/main" val="1668921717"/>
                    </a:ext>
                  </a:extLst>
                </a:gridCol>
                <a:gridCol w="2070100">
                  <a:extLst>
                    <a:ext uri="{9D8B030D-6E8A-4147-A177-3AD203B41FA5}">
                      <a16:colId xmlns:a16="http://schemas.microsoft.com/office/drawing/2014/main" val="4053947187"/>
                    </a:ext>
                  </a:extLst>
                </a:gridCol>
                <a:gridCol w="1436370">
                  <a:extLst>
                    <a:ext uri="{9D8B030D-6E8A-4147-A177-3AD203B41FA5}">
                      <a16:colId xmlns:a16="http://schemas.microsoft.com/office/drawing/2014/main" val="3963416707"/>
                    </a:ext>
                  </a:extLst>
                </a:gridCol>
              </a:tblGrid>
              <a:tr h="17526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equence (5’</a:t>
                      </a: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’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CR product (bp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3310701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c (PYD and CARD domain containing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GACAGTACCAGGCAGTTCGT</a:t>
                      </a: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5694359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AGTCCTTGCAGGTCAGGTTC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4925243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AU" sz="8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glyceraldehyde-3-phosphate dehydrogenase)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TCCATGACAACTTTGGCATT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0025718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CAGTCTTCTGGGTGGCAGTG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2242971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sp1 (Caspase 1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CACGCCCTGTTGGAAAGGA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072627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CCCTCAGGATCTTGTCAGCC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488447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l5 (Chemokine (C-C motif) ligand 5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/>
                          <a:cs typeface="Arial" panose="020B0604020202020204" pitchFamily="34" charset="0"/>
                        </a:rPr>
                        <a:t>F: TTTGCCTACCTCTCCCTC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944563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/>
                          <a:cs typeface="Arial" panose="020B0604020202020204" pitchFamily="34" charset="0"/>
                        </a:rPr>
                        <a:t>R: CGACTGCAAGATTGGAGCACT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4156684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sf1 (Colony stimulating factor 1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GAACAAGGCCTGTGTCCGAA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1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282731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CCACATCTCGGCTAGAGCAC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8454735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sf2 (Colony-stimulating factor 2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AACTCCGGAAACGGACTGT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5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613836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AAGCTGGATTCAGAGCTGGC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8483586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0 (Interleukin 10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GCTCTTACTGACTGGCATGA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5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716355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CGCAGCTCTAGGAGCATGT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2163474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8 (Interleukin 18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CCTTTGAGGCATCCAGGAC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8872893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GGGAACAGCCAGTGTTCAGT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0078583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a (Interleukin 1 alpha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GTATGCCTACTCGTCGGGA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173159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GGCAACTCCTTCAGCAACAC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94541014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b (Interleukin 1 beta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GAAGAAGAGCCCATCCTCT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2330865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GGAGCCTGTAGTGCAGTTGT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2459498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6 (Interleukin 6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CTGCAAGAGACTTCCATCCA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1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3893724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AGTGGTATAGACAGGTCTGTTG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6947573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lrp3 (NLR family, pyrin domain containing 3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CAGAGCCTACAGTTGGGTG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3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320920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TAGCAGTGAAGAGCAGTGC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1173314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pt-PT" sz="8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nfa (Tumor necrosis factor alpha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: CCTGGCCTCTCTACCTTGTTG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6210425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: AGCCTGGTCACCAAATCAGC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0163554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E91F7673-7606-4F49-AF36-5876D619C7F0}"/>
              </a:ext>
            </a:extLst>
          </p:cNvPr>
          <p:cNvSpPr/>
          <p:nvPr/>
        </p:nvSpPr>
        <p:spPr>
          <a:xfrm>
            <a:off x="640715" y="2870616"/>
            <a:ext cx="56625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2</a:t>
            </a:r>
            <a:r>
              <a:rPr lang="en-AU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List of primers used for gene expression analysis.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64509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70D5B11-FA00-4F2D-845D-EA31497723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6990849"/>
              </p:ext>
            </p:extLst>
          </p:nvPr>
        </p:nvGraphicFramePr>
        <p:xfrm>
          <a:off x="685165" y="3251854"/>
          <a:ext cx="5487670" cy="3114675"/>
        </p:xfrm>
        <a:graphic>
          <a:graphicData uri="http://schemas.openxmlformats.org/drawingml/2006/table">
            <a:tbl>
              <a:tblPr firstRow="1" firstCol="1" bandRow="1"/>
              <a:tblGrid>
                <a:gridCol w="922020">
                  <a:extLst>
                    <a:ext uri="{9D8B030D-6E8A-4147-A177-3AD203B41FA5}">
                      <a16:colId xmlns:a16="http://schemas.microsoft.com/office/drawing/2014/main" val="1733960091"/>
                    </a:ext>
                  </a:extLst>
                </a:gridCol>
                <a:gridCol w="973455">
                  <a:extLst>
                    <a:ext uri="{9D8B030D-6E8A-4147-A177-3AD203B41FA5}">
                      <a16:colId xmlns:a16="http://schemas.microsoft.com/office/drawing/2014/main" val="434277436"/>
                    </a:ext>
                  </a:extLst>
                </a:gridCol>
                <a:gridCol w="817245">
                  <a:extLst>
                    <a:ext uri="{9D8B030D-6E8A-4147-A177-3AD203B41FA5}">
                      <a16:colId xmlns:a16="http://schemas.microsoft.com/office/drawing/2014/main" val="2867293058"/>
                    </a:ext>
                  </a:extLst>
                </a:gridCol>
                <a:gridCol w="972185">
                  <a:extLst>
                    <a:ext uri="{9D8B030D-6E8A-4147-A177-3AD203B41FA5}">
                      <a16:colId xmlns:a16="http://schemas.microsoft.com/office/drawing/2014/main" val="3846974216"/>
                    </a:ext>
                  </a:extLst>
                </a:gridCol>
                <a:gridCol w="826135">
                  <a:extLst>
                    <a:ext uri="{9D8B030D-6E8A-4147-A177-3AD203B41FA5}">
                      <a16:colId xmlns:a16="http://schemas.microsoft.com/office/drawing/2014/main" val="2759355556"/>
                    </a:ext>
                  </a:extLst>
                </a:gridCol>
                <a:gridCol w="976630">
                  <a:extLst>
                    <a:ext uri="{9D8B030D-6E8A-4147-A177-3AD203B41FA5}">
                      <a16:colId xmlns:a16="http://schemas.microsoft.com/office/drawing/2014/main" val="1106072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jugate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lon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pecificity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centration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27534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19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V65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D3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 cells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4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63235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8997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4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UV395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K1.5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AU" sz="800" baseline="30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 cells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4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6379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055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8a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rCP-Cy5.5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-6.7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AU" sz="800" baseline="30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 cells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4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51162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2012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11b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1/7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11b</a:t>
                      </a:r>
                      <a:r>
                        <a:rPr lang="en-AU" sz="8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ells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4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57396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4941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4/8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45-2342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crophages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6541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4651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K1.1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-Cy7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K136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K cells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60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52878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6890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CRβ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V51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57-597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 cells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40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63221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484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ve/Dead Viability Stain 70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VS70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ad cells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D Biosciences, 564997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7073025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3C634902-09A0-420D-8D50-E6F08A79AA46}"/>
              </a:ext>
            </a:extLst>
          </p:cNvPr>
          <p:cNvSpPr/>
          <p:nvPr/>
        </p:nvSpPr>
        <p:spPr>
          <a:xfrm>
            <a:off x="685165" y="2875123"/>
            <a:ext cx="548766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3</a:t>
            </a:r>
            <a:r>
              <a:rPr lang="en-AU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List of antibodies and other stains used for Flow Cytometry.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1352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16</TotalTime>
  <Words>489</Words>
  <Application>Microsoft Office PowerPoint</Application>
  <PresentationFormat>A4 Paper (210x297 mm)</PresentationFormat>
  <Paragraphs>144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a Lliberos Requesens</dc:creator>
  <cp:lastModifiedBy>Carolina Lliberos Requesens</cp:lastModifiedBy>
  <cp:revision>286</cp:revision>
  <dcterms:created xsi:type="dcterms:W3CDTF">2020-07-15T01:36:30Z</dcterms:created>
  <dcterms:modified xsi:type="dcterms:W3CDTF">2020-12-15T07:55:38Z</dcterms:modified>
</cp:coreProperties>
</file>